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 bookmarkIdSeed="2">
  <p:sldMasterIdLst>
    <p:sldMasterId id="2147483648" r:id="rId1"/>
  </p:sldMasterIdLst>
  <p:notesMasterIdLst>
    <p:notesMasterId r:id="rId5"/>
  </p:notesMasterIdLst>
  <p:sldIdLst>
    <p:sldId id="272" r:id="rId2"/>
    <p:sldId id="258" r:id="rId3"/>
    <p:sldId id="271" r:id="rId4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9900"/>
    <a:srgbClr val="FF0000"/>
    <a:srgbClr val="CC00CC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>
        <p:scale>
          <a:sx n="81" d="100"/>
          <a:sy n="81" d="100"/>
        </p:scale>
        <p:origin x="-1326" y="-7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8F22A7-131E-458F-A98D-39EA7C873D05}" type="datetimeFigureOut">
              <a:rPr lang="en-GB" smtClean="0"/>
              <a:t>21/09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98349E-1EAA-430C-B8F5-D1CE7B1E5F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7641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5F423-10A7-48AC-88E8-93D305982EC7}" type="datetime1">
              <a:rPr lang="en-GB" smtClean="0"/>
              <a:t>2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737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3ED18-1641-4DB4-93E8-77D3EC2F8046}" type="datetime1">
              <a:rPr lang="en-GB" smtClean="0"/>
              <a:t>2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4887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F4EF6-5232-48C9-B815-0F384AA6A50F}" type="datetime1">
              <a:rPr lang="en-GB" smtClean="0"/>
              <a:t>2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612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3E4F4-57FE-4EA2-A35F-165349DBD2BF}" type="datetime1">
              <a:rPr lang="en-GB" smtClean="0"/>
              <a:t>2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004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7848A-EE9F-400D-BEF4-DB889454CFE2}" type="datetime1">
              <a:rPr lang="en-GB" smtClean="0"/>
              <a:t>2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53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2277-AB46-41F1-9876-327D470D2039}" type="datetime1">
              <a:rPr lang="en-GB" smtClean="0"/>
              <a:t>21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3347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2CA3-173C-49B2-91D5-1E4A9020DBCF}" type="datetime1">
              <a:rPr lang="en-GB" smtClean="0"/>
              <a:t>21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6096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B3913-09E0-481A-BC09-61DC77702212}" type="datetime1">
              <a:rPr lang="en-GB" smtClean="0"/>
              <a:t>21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04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676B-3E9C-4A54-8202-28F0206ED78F}" type="datetime1">
              <a:rPr lang="en-GB" smtClean="0"/>
              <a:t>21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2121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FFF-764F-46D1-9363-F070A8D56024}" type="datetime1">
              <a:rPr lang="en-GB" smtClean="0"/>
              <a:t>21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574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2DCEF-7E52-4E8F-B9E2-C7840E0B31E2}" type="datetime1">
              <a:rPr lang="en-GB" smtClean="0"/>
              <a:t>21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234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6776EA-4B72-4581-B850-2AB2C42BE536}" type="datetime1">
              <a:rPr lang="en-GB" smtClean="0"/>
              <a:t>21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132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.fry@ed.ac.uk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B897B11B-4C78-4182-99AD-0E4ECB509625}"/>
              </a:ext>
            </a:extLst>
          </p:cNvPr>
          <p:cNvSpPr txBox="1"/>
          <p:nvPr/>
        </p:nvSpPr>
        <p:spPr>
          <a:xfrm>
            <a:off x="704528" y="476672"/>
            <a:ext cx="8294877" cy="37955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sz="1400" b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Pectin-like heteroxylans in the early-diverging charophyte </a:t>
            </a:r>
            <a:r>
              <a:rPr lang="en-GB" sz="1400" b="1" i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Klebsormidium fluitans</a:t>
            </a:r>
            <a:endParaRPr lang="en-GB" sz="14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sz="11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 </a:t>
            </a:r>
            <a:endParaRPr lang="en-GB" sz="11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sz="11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Marie N. Rapin,</a:t>
            </a:r>
            <a:r>
              <a:rPr lang="en-GB" sz="1100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1,† </a:t>
            </a:r>
            <a:r>
              <a:rPr lang="en-GB" sz="11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 John H. Bothwell,</a:t>
            </a:r>
            <a:r>
              <a:rPr lang="en-GB" sz="1100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2</a:t>
            </a:r>
            <a:r>
              <a:rPr lang="en-GB" sz="11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 Stephen C. Fry</a:t>
            </a:r>
            <a:r>
              <a:rPr lang="en-GB" sz="1100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1,*</a:t>
            </a:r>
            <a:endParaRPr lang="en-GB" sz="11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sz="1100" i="1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1 </a:t>
            </a:r>
            <a:r>
              <a:rPr lang="en-GB" sz="1100" i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The Edinburgh Cell Wall Group, Institute of Molecular Plant Sciences, The University of Edinburgh, Daniel Rutherford Building, The King’s Buildings, Max Born Crescent, Edinburgh EH9 3BF, UK.</a:t>
            </a:r>
            <a:endParaRPr lang="en-GB" sz="11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sz="1100" i="1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2</a:t>
            </a:r>
            <a:r>
              <a:rPr lang="en-GB" sz="1100" i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 Department of Biosciences, Durham University, South Road, Durham, DH1 3LE, UK.</a:t>
            </a:r>
            <a:endParaRPr lang="en-GB" sz="11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sz="1100" i="1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†</a:t>
            </a:r>
            <a:r>
              <a:rPr lang="en-GB" sz="1100" i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 Present address:</a:t>
            </a:r>
            <a:r>
              <a:rPr lang="en-GB" sz="1100" i="1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 </a:t>
            </a:r>
            <a:r>
              <a:rPr lang="en-GB" sz="1100" i="1" dirty="0" err="1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Huid</a:t>
            </a:r>
            <a:r>
              <a:rPr lang="en-GB" sz="1100" i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, Suite 11, Malin House, European Marine Science Park, Dunbeg, PA37 1SZ, UK.</a:t>
            </a:r>
            <a:endParaRPr lang="en-GB" sz="11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sz="1100" i="1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*</a:t>
            </a:r>
            <a:r>
              <a:rPr lang="en-GB" sz="1100" i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For correspondence. E-mail </a:t>
            </a:r>
            <a:r>
              <a:rPr lang="en-GB" sz="1100" i="1" u="sng" dirty="0">
                <a:solidFill>
                  <a:srgbClr val="0000FF"/>
                </a:solidFill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  <a:hlinkClick r:id="rId2"/>
              </a:rPr>
              <a:t>s.fry@ed.ac.uk</a:t>
            </a:r>
            <a:endParaRPr lang="en-GB" sz="11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endParaRPr lang="en-GB" sz="1100" dirty="0"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endParaRPr lang="en-GB" sz="11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600"/>
              </a:spcAft>
            </a:pPr>
            <a:r>
              <a:rPr lang="en-GB" sz="2000" b="1" dirty="0">
                <a:latin typeface="Century Schoolbook" panose="02040604050505020304" pitchFamily="18" charset="0"/>
                <a:ea typeface="Calibri" panose="020F0502020204030204" pitchFamily="34" charset="0"/>
              </a:rPr>
              <a:t>Supplementary data</a:t>
            </a:r>
            <a:endParaRPr lang="en-GB" sz="2000" b="1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72834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9374FFD3-83AE-4860-8E19-F9FF12A9E48F}"/>
              </a:ext>
            </a:extLst>
          </p:cNvPr>
          <p:cNvSpPr txBox="1"/>
          <p:nvPr/>
        </p:nvSpPr>
        <p:spPr>
          <a:xfrm>
            <a:off x="776535" y="5517232"/>
            <a:ext cx="8491291" cy="9790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GB" sz="1000" b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Fig. S1: Sugar residue composition </a:t>
            </a:r>
            <a:r>
              <a:rPr lang="en-GB" sz="1000" b="1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of the pectic fraction from </a:t>
            </a:r>
            <a:r>
              <a:rPr lang="en-GB" sz="1000" b="1" i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Klebsormidium </a:t>
            </a:r>
            <a:r>
              <a:rPr lang="en-GB" sz="1000" b="1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AIR.</a:t>
            </a:r>
            <a:endParaRPr lang="en-GB" sz="10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GB" sz="100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Pectin fraction </a:t>
            </a:r>
            <a:r>
              <a:rPr lang="en-GB" sz="1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extracts were obtained (as sequential 2-h and 16-h extracts, independently at each temperature) with a range of buffers (all pH 4.1), incubation times and temperatures (as in Fig. 1c). The 20 and 60°C extracts were re-concentrated to 5 </a:t>
            </a:r>
            <a:r>
              <a:rPr lang="en-GB" sz="1000" dirty="0" err="1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mg.mL</a:t>
            </a:r>
            <a:r>
              <a:rPr lang="en-GB" sz="1000" baseline="30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–1</a:t>
            </a:r>
            <a:r>
              <a:rPr lang="en-GB" sz="1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, thus </a:t>
            </a:r>
            <a:r>
              <a:rPr lang="en-GB" sz="100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yielding a detectable pectic fraction even </a:t>
            </a:r>
            <a:r>
              <a:rPr lang="en-GB" sz="1000" dirty="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if the yield was low. The 100°C extracts were not concentrated in this way and thus show fainter bands in this Fig. All extracts were hydrolysed with TFA (2 M, 120°C, 1 h) and the products analysed by TLC (in EPAW, with two ascents).</a:t>
            </a:r>
            <a:endParaRPr lang="en-GB" sz="1000" dirty="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304" name="Group 303">
            <a:extLst>
              <a:ext uri="{FF2B5EF4-FFF2-40B4-BE49-F238E27FC236}">
                <a16:creationId xmlns:a16="http://schemas.microsoft.com/office/drawing/2014/main" xmlns="" id="{313A7A3A-DBA1-B2CB-7849-25C7FD8BF163}"/>
              </a:ext>
            </a:extLst>
          </p:cNvPr>
          <p:cNvGrpSpPr>
            <a:grpSpLocks noChangeAspect="1"/>
          </p:cNvGrpSpPr>
          <p:nvPr/>
        </p:nvGrpSpPr>
        <p:grpSpPr>
          <a:xfrm>
            <a:off x="560512" y="373583"/>
            <a:ext cx="8799360" cy="5083780"/>
            <a:chOff x="560512" y="373583"/>
            <a:chExt cx="8799360" cy="5083780"/>
          </a:xfrm>
        </p:grpSpPr>
        <p:grpSp>
          <p:nvGrpSpPr>
            <p:cNvPr id="280" name="Group 279">
              <a:extLst>
                <a:ext uri="{FF2B5EF4-FFF2-40B4-BE49-F238E27FC236}">
                  <a16:creationId xmlns:a16="http://schemas.microsoft.com/office/drawing/2014/main" xmlns="" id="{B55725CA-D8B1-4ADD-9244-4AA3AE7606D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60512" y="373583"/>
              <a:ext cx="8527991" cy="5083780"/>
              <a:chOff x="739836" y="373583"/>
              <a:chExt cx="8527991" cy="5083780"/>
            </a:xfrm>
          </p:grpSpPr>
          <p:pic>
            <p:nvPicPr>
              <p:cNvPr id="181" name="Google Shape;89;p1">
                <a:extLst>
                  <a:ext uri="{FF2B5EF4-FFF2-40B4-BE49-F238E27FC236}">
                    <a16:creationId xmlns:a16="http://schemas.microsoft.com/office/drawing/2014/main" xmlns="" id="{5AAD789C-4ECF-7A56-4C83-C5B638CDA248}"/>
                  </a:ext>
                </a:extLst>
              </p:cNvPr>
              <p:cNvPicPr preferRelativeResize="0"/>
              <p:nvPr/>
            </p:nvPicPr>
            <p:blipFill rotWithShape="1">
              <a:blip r:embed="rId2">
                <a:alphaModFix/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0510" t="21062" r="4606" b="10005"/>
              <a:stretch/>
            </p:blipFill>
            <p:spPr>
              <a:xfrm>
                <a:off x="4212607" y="373583"/>
                <a:ext cx="4525279" cy="420014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82" name="Google Shape;90;p1">
                <a:extLst>
                  <a:ext uri="{FF2B5EF4-FFF2-40B4-BE49-F238E27FC236}">
                    <a16:creationId xmlns:a16="http://schemas.microsoft.com/office/drawing/2014/main" xmlns="" id="{F0B68612-BDBC-5CF9-D8C5-22E8A97C554E}"/>
                  </a:ext>
                </a:extLst>
              </p:cNvPr>
              <p:cNvPicPr preferRelativeResize="0"/>
              <p:nvPr/>
            </p:nvPicPr>
            <p:blipFill rotWithShape="1">
              <a:blip r:embed="rId4">
                <a:alphaModFix/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6861" t="10241" r="7372" b="10331"/>
              <a:stretch/>
            </p:blipFill>
            <p:spPr>
              <a:xfrm>
                <a:off x="1244275" y="457182"/>
                <a:ext cx="2920583" cy="4121458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83" name="Google Shape;91;p1">
                <a:extLst>
                  <a:ext uri="{FF2B5EF4-FFF2-40B4-BE49-F238E27FC236}">
                    <a16:creationId xmlns:a16="http://schemas.microsoft.com/office/drawing/2014/main" xmlns="" id="{0B52AD4A-2FF0-29C1-5629-313F1369D4D1}"/>
                  </a:ext>
                </a:extLst>
              </p:cNvPr>
              <p:cNvSpPr txBox="1"/>
              <p:nvPr/>
            </p:nvSpPr>
            <p:spPr>
              <a:xfrm>
                <a:off x="739836" y="814784"/>
                <a:ext cx="328616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Me-Xyl</a:t>
                </a:r>
                <a:endParaRPr sz="1000" kern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84" name="Google Shape;92;p1">
                <a:extLst>
                  <a:ext uri="{FF2B5EF4-FFF2-40B4-BE49-F238E27FC236}">
                    <a16:creationId xmlns:a16="http://schemas.microsoft.com/office/drawing/2014/main" xmlns="" id="{3D79293F-EFAB-18F9-E129-48ABA9C8BFC9}"/>
                  </a:ext>
                </a:extLst>
              </p:cNvPr>
              <p:cNvSpPr txBox="1"/>
              <p:nvPr/>
            </p:nvSpPr>
            <p:spPr>
              <a:xfrm>
                <a:off x="877694" y="1068671"/>
                <a:ext cx="19075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Rha</a:t>
                </a:r>
                <a:endParaRPr sz="1000" kern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85" name="Google Shape;93;p1">
                <a:extLst>
                  <a:ext uri="{FF2B5EF4-FFF2-40B4-BE49-F238E27FC236}">
                    <a16:creationId xmlns:a16="http://schemas.microsoft.com/office/drawing/2014/main" xmlns="" id="{02634A11-E00A-FFA4-FF25-F74920E40D26}"/>
                  </a:ext>
                </a:extLst>
              </p:cNvPr>
              <p:cNvSpPr txBox="1"/>
              <p:nvPr/>
            </p:nvSpPr>
            <p:spPr>
              <a:xfrm>
                <a:off x="920976" y="1586814"/>
                <a:ext cx="147476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Xyl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86" name="Google Shape;94;p1">
                <a:extLst>
                  <a:ext uri="{FF2B5EF4-FFF2-40B4-BE49-F238E27FC236}">
                    <a16:creationId xmlns:a16="http://schemas.microsoft.com/office/drawing/2014/main" xmlns="" id="{15096290-7B52-680A-502E-085550FBC5CC}"/>
                  </a:ext>
                </a:extLst>
              </p:cNvPr>
              <p:cNvSpPr txBox="1"/>
              <p:nvPr/>
            </p:nvSpPr>
            <p:spPr>
              <a:xfrm>
                <a:off x="834414" y="4233423"/>
                <a:ext cx="23403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GalA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87" name="Google Shape;95;p1">
                <a:extLst>
                  <a:ext uri="{FF2B5EF4-FFF2-40B4-BE49-F238E27FC236}">
                    <a16:creationId xmlns:a16="http://schemas.microsoft.com/office/drawing/2014/main" xmlns="" id="{CD9A081A-B475-60A0-B984-C0498731F5EB}"/>
                  </a:ext>
                </a:extLst>
              </p:cNvPr>
              <p:cNvSpPr txBox="1"/>
              <p:nvPr/>
            </p:nvSpPr>
            <p:spPr>
              <a:xfrm>
                <a:off x="911358" y="1464896"/>
                <a:ext cx="157094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Rib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188" name="Google Shape;96;p1">
                <a:extLst>
                  <a:ext uri="{FF2B5EF4-FFF2-40B4-BE49-F238E27FC236}">
                    <a16:creationId xmlns:a16="http://schemas.microsoft.com/office/drawing/2014/main" xmlns="" id="{6A087B70-59E6-9B8F-9FBD-A848305B2651}"/>
                  </a:ext>
                </a:extLst>
              </p:cNvPr>
              <p:cNvSpPr txBox="1"/>
              <p:nvPr/>
            </p:nvSpPr>
            <p:spPr>
              <a:xfrm>
                <a:off x="839223" y="4083723"/>
                <a:ext cx="229229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GlcA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89" name="Google Shape;97;p1">
                <a:extLst>
                  <a:ext uri="{FF2B5EF4-FFF2-40B4-BE49-F238E27FC236}">
                    <a16:creationId xmlns:a16="http://schemas.microsoft.com/office/drawing/2014/main" xmlns="" id="{D7A7A9B3-C71C-E11A-F269-84F3CF689E8C}"/>
                  </a:ext>
                </a:extLst>
              </p:cNvPr>
              <p:cNvSpPr txBox="1"/>
              <p:nvPr/>
            </p:nvSpPr>
            <p:spPr>
              <a:xfrm>
                <a:off x="904947" y="2087161"/>
                <a:ext cx="163506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Ara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190" name="Google Shape;98;p1">
                <a:extLst>
                  <a:ext uri="{FF2B5EF4-FFF2-40B4-BE49-F238E27FC236}">
                    <a16:creationId xmlns:a16="http://schemas.microsoft.com/office/drawing/2014/main" xmlns="" id="{D8A3C16B-7EA0-D532-90AD-2AF2DAC1AD79}"/>
                  </a:ext>
                </a:extLst>
              </p:cNvPr>
              <p:cNvSpPr txBox="1"/>
              <p:nvPr/>
            </p:nvSpPr>
            <p:spPr>
              <a:xfrm>
                <a:off x="864871" y="2326057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Man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191" name="Google Shape;99;p1">
                <a:extLst>
                  <a:ext uri="{FF2B5EF4-FFF2-40B4-BE49-F238E27FC236}">
                    <a16:creationId xmlns:a16="http://schemas.microsoft.com/office/drawing/2014/main" xmlns="" id="{4E36EBC6-A244-B4A4-C3B4-42C529FA543D}"/>
                  </a:ext>
                </a:extLst>
              </p:cNvPr>
              <p:cNvSpPr txBox="1"/>
              <p:nvPr/>
            </p:nvSpPr>
            <p:spPr>
              <a:xfrm>
                <a:off x="909754" y="2507829"/>
                <a:ext cx="15869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Gl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92" name="Google Shape;100;p1">
                <a:extLst>
                  <a:ext uri="{FF2B5EF4-FFF2-40B4-BE49-F238E27FC236}">
                    <a16:creationId xmlns:a16="http://schemas.microsoft.com/office/drawing/2014/main" xmlns="" id="{209CE50E-5C68-A932-DEE3-77E42851E87A}"/>
                  </a:ext>
                </a:extLst>
              </p:cNvPr>
              <p:cNvSpPr txBox="1"/>
              <p:nvPr/>
            </p:nvSpPr>
            <p:spPr>
              <a:xfrm>
                <a:off x="904946" y="2854604"/>
                <a:ext cx="163506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Gal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193" name="Google Shape;101;p1">
                <a:extLst>
                  <a:ext uri="{FF2B5EF4-FFF2-40B4-BE49-F238E27FC236}">
                    <a16:creationId xmlns:a16="http://schemas.microsoft.com/office/drawing/2014/main" xmlns="" id="{6E0DECA7-3B4C-F851-A4DD-00CE64E70EA2}"/>
                  </a:ext>
                </a:extLst>
              </p:cNvPr>
              <p:cNvSpPr txBox="1"/>
              <p:nvPr/>
            </p:nvSpPr>
            <p:spPr>
              <a:xfrm>
                <a:off x="893725" y="1715496"/>
                <a:ext cx="17472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Fu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94" name="Google Shape;113;p1">
                <a:extLst>
                  <a:ext uri="{FF2B5EF4-FFF2-40B4-BE49-F238E27FC236}">
                    <a16:creationId xmlns:a16="http://schemas.microsoft.com/office/drawing/2014/main" xmlns="" id="{D904ADED-D1D3-4132-D9C3-2880F5DD2E81}"/>
                  </a:ext>
                </a:extLst>
              </p:cNvPr>
              <p:cNvSpPr txBox="1"/>
              <p:nvPr/>
            </p:nvSpPr>
            <p:spPr>
              <a:xfrm>
                <a:off x="2636949" y="5180334"/>
                <a:ext cx="1034228" cy="2769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91425" tIns="45700" rIns="91425" bIns="4570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200" b="1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Oxalate buffer</a:t>
                </a:r>
                <a:endParaRPr sz="1200" b="1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195" name="Google Shape;114;p1">
                <a:extLst>
                  <a:ext uri="{FF2B5EF4-FFF2-40B4-BE49-F238E27FC236}">
                    <a16:creationId xmlns:a16="http://schemas.microsoft.com/office/drawing/2014/main" xmlns="" id="{63349BB6-9A34-9D99-C98E-57E8056412F5}"/>
                  </a:ext>
                </a:extLst>
              </p:cNvPr>
              <p:cNvSpPr/>
              <p:nvPr/>
            </p:nvSpPr>
            <p:spPr>
              <a:xfrm rot="16200000">
                <a:off x="3063789" y="4233167"/>
                <a:ext cx="175256" cy="1718491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97" name="Google Shape;116;p1">
                <a:extLst>
                  <a:ext uri="{FF2B5EF4-FFF2-40B4-BE49-F238E27FC236}">
                    <a16:creationId xmlns:a16="http://schemas.microsoft.com/office/drawing/2014/main" xmlns="" id="{58228CCF-A314-21E0-8091-289D12620D5B}"/>
                  </a:ext>
                </a:extLst>
              </p:cNvPr>
              <p:cNvSpPr txBox="1"/>
              <p:nvPr/>
            </p:nvSpPr>
            <p:spPr>
              <a:xfrm>
                <a:off x="4557386" y="5180334"/>
                <a:ext cx="1034227" cy="2769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91425" tIns="45700" rIns="91425" bIns="4570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200" b="1" kern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Acetate buffer</a:t>
                </a:r>
                <a:endParaRPr sz="1200" b="1" kern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198" name="Google Shape;117;p1">
                <a:extLst>
                  <a:ext uri="{FF2B5EF4-FFF2-40B4-BE49-F238E27FC236}">
                    <a16:creationId xmlns:a16="http://schemas.microsoft.com/office/drawing/2014/main" xmlns="" id="{F87812FB-601E-6D6D-26BE-2226EF9E9021}"/>
                  </a:ext>
                </a:extLst>
              </p:cNvPr>
              <p:cNvSpPr/>
              <p:nvPr/>
            </p:nvSpPr>
            <p:spPr>
              <a:xfrm rot="16200000">
                <a:off x="4984225" y="4233460"/>
                <a:ext cx="175256" cy="1718491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00" name="Google Shape;119;p1">
                <a:extLst>
                  <a:ext uri="{FF2B5EF4-FFF2-40B4-BE49-F238E27FC236}">
                    <a16:creationId xmlns:a16="http://schemas.microsoft.com/office/drawing/2014/main" xmlns="" id="{A5C2C49C-E666-0603-B40D-206AB5B0C8D3}"/>
                  </a:ext>
                </a:extLst>
              </p:cNvPr>
              <p:cNvSpPr txBox="1"/>
              <p:nvPr/>
            </p:nvSpPr>
            <p:spPr>
              <a:xfrm>
                <a:off x="6318954" y="5180404"/>
                <a:ext cx="1075905" cy="2769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91425" tIns="45700" rIns="91425" bIns="4570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200" b="1" kern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Formate buffer</a:t>
                </a:r>
                <a:endParaRPr sz="1200" b="1" kern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201" name="Google Shape;120;p1">
                <a:extLst>
                  <a:ext uri="{FF2B5EF4-FFF2-40B4-BE49-F238E27FC236}">
                    <a16:creationId xmlns:a16="http://schemas.microsoft.com/office/drawing/2014/main" xmlns="" id="{C1D2106A-759A-E9EE-E82A-761CD285AB72}"/>
                  </a:ext>
                </a:extLst>
              </p:cNvPr>
              <p:cNvSpPr/>
              <p:nvPr/>
            </p:nvSpPr>
            <p:spPr>
              <a:xfrm rot="16200000">
                <a:off x="6766632" y="4233677"/>
                <a:ext cx="175256" cy="1718491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03" name="Google Shape;122;p1">
                <a:extLst>
                  <a:ext uri="{FF2B5EF4-FFF2-40B4-BE49-F238E27FC236}">
                    <a16:creationId xmlns:a16="http://schemas.microsoft.com/office/drawing/2014/main" xmlns="" id="{5AD1DC7F-6499-DE01-9D31-50EDAD5417FB}"/>
                  </a:ext>
                </a:extLst>
              </p:cNvPr>
              <p:cNvSpPr txBox="1"/>
              <p:nvPr/>
            </p:nvSpPr>
            <p:spPr>
              <a:xfrm>
                <a:off x="8939211" y="787456"/>
                <a:ext cx="328616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Me-Xyl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04" name="Google Shape;123;p1">
                <a:extLst>
                  <a:ext uri="{FF2B5EF4-FFF2-40B4-BE49-F238E27FC236}">
                    <a16:creationId xmlns:a16="http://schemas.microsoft.com/office/drawing/2014/main" xmlns="" id="{4DFB194D-9201-1470-1E29-CE63082AC925}"/>
                  </a:ext>
                </a:extLst>
              </p:cNvPr>
              <p:cNvSpPr txBox="1"/>
              <p:nvPr/>
            </p:nvSpPr>
            <p:spPr>
              <a:xfrm>
                <a:off x="8939211" y="1040483"/>
                <a:ext cx="19075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Rha</a:t>
                </a:r>
                <a:endParaRPr sz="1000" kern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05" name="Google Shape;124;p1">
                <a:extLst>
                  <a:ext uri="{FF2B5EF4-FFF2-40B4-BE49-F238E27FC236}">
                    <a16:creationId xmlns:a16="http://schemas.microsoft.com/office/drawing/2014/main" xmlns="" id="{F25F8B04-7F74-6A1B-0F19-A41E6E3D6A09}"/>
                  </a:ext>
                </a:extLst>
              </p:cNvPr>
              <p:cNvSpPr txBox="1"/>
              <p:nvPr/>
            </p:nvSpPr>
            <p:spPr>
              <a:xfrm>
                <a:off x="8939211" y="1551194"/>
                <a:ext cx="157094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Rib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06" name="Google Shape;125;p1">
                <a:extLst>
                  <a:ext uri="{FF2B5EF4-FFF2-40B4-BE49-F238E27FC236}">
                    <a16:creationId xmlns:a16="http://schemas.microsoft.com/office/drawing/2014/main" xmlns="" id="{60DF4C08-A043-BAF0-9CB9-1EC08E09784C}"/>
                  </a:ext>
                </a:extLst>
              </p:cNvPr>
              <p:cNvSpPr txBox="1"/>
              <p:nvPr/>
            </p:nvSpPr>
            <p:spPr>
              <a:xfrm>
                <a:off x="8939211" y="4214232"/>
                <a:ext cx="23403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GalA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07" name="Google Shape;126;p1">
                <a:extLst>
                  <a:ext uri="{FF2B5EF4-FFF2-40B4-BE49-F238E27FC236}">
                    <a16:creationId xmlns:a16="http://schemas.microsoft.com/office/drawing/2014/main" xmlns="" id="{00363A21-9940-6689-6069-F54BEDEF1A59}"/>
                  </a:ext>
                </a:extLst>
              </p:cNvPr>
              <p:cNvSpPr txBox="1"/>
              <p:nvPr/>
            </p:nvSpPr>
            <p:spPr>
              <a:xfrm>
                <a:off x="8939211" y="1417575"/>
                <a:ext cx="147476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Xyl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208" name="Google Shape;127;p1">
                <a:extLst>
                  <a:ext uri="{FF2B5EF4-FFF2-40B4-BE49-F238E27FC236}">
                    <a16:creationId xmlns:a16="http://schemas.microsoft.com/office/drawing/2014/main" xmlns="" id="{D1779824-B6A1-5499-6287-1DEA140E907D}"/>
                  </a:ext>
                </a:extLst>
              </p:cNvPr>
              <p:cNvSpPr txBox="1"/>
              <p:nvPr/>
            </p:nvSpPr>
            <p:spPr>
              <a:xfrm>
                <a:off x="8939211" y="4073055"/>
                <a:ext cx="229230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GlcA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09" name="Google Shape;128;p1">
                <a:extLst>
                  <a:ext uri="{FF2B5EF4-FFF2-40B4-BE49-F238E27FC236}">
                    <a16:creationId xmlns:a16="http://schemas.microsoft.com/office/drawing/2014/main" xmlns="" id="{F5AEC55E-7ABB-3EB5-CB3E-6716609AA19D}"/>
                  </a:ext>
                </a:extLst>
              </p:cNvPr>
              <p:cNvSpPr txBox="1"/>
              <p:nvPr/>
            </p:nvSpPr>
            <p:spPr>
              <a:xfrm>
                <a:off x="8939211" y="2043648"/>
                <a:ext cx="163506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Ara</a:t>
                </a:r>
                <a:endParaRPr sz="1000" kern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210" name="Google Shape;129;p1">
                <a:extLst>
                  <a:ext uri="{FF2B5EF4-FFF2-40B4-BE49-F238E27FC236}">
                    <a16:creationId xmlns:a16="http://schemas.microsoft.com/office/drawing/2014/main" xmlns="" id="{B5449AA2-57C1-4BEE-FB00-A891074F0D69}"/>
                  </a:ext>
                </a:extLst>
              </p:cNvPr>
              <p:cNvSpPr txBox="1"/>
              <p:nvPr/>
            </p:nvSpPr>
            <p:spPr>
              <a:xfrm>
                <a:off x="8939211" y="2422440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Man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211" name="Google Shape;130;p1">
                <a:extLst>
                  <a:ext uri="{FF2B5EF4-FFF2-40B4-BE49-F238E27FC236}">
                    <a16:creationId xmlns:a16="http://schemas.microsoft.com/office/drawing/2014/main" xmlns="" id="{C1E92F83-3FEB-31FB-9036-154244D245CE}"/>
                  </a:ext>
                </a:extLst>
              </p:cNvPr>
              <p:cNvSpPr txBox="1"/>
              <p:nvPr/>
            </p:nvSpPr>
            <p:spPr>
              <a:xfrm>
                <a:off x="8939211" y="2613683"/>
                <a:ext cx="15869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Glc</a:t>
                </a:r>
                <a:endParaRPr sz="1000" kern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12" name="Google Shape;131;p1">
                <a:extLst>
                  <a:ext uri="{FF2B5EF4-FFF2-40B4-BE49-F238E27FC236}">
                    <a16:creationId xmlns:a16="http://schemas.microsoft.com/office/drawing/2014/main" xmlns="" id="{D19269E5-3B25-851C-5ED5-CF303CFD1462}"/>
                  </a:ext>
                </a:extLst>
              </p:cNvPr>
              <p:cNvSpPr txBox="1"/>
              <p:nvPr/>
            </p:nvSpPr>
            <p:spPr>
              <a:xfrm>
                <a:off x="8939211" y="2965872"/>
                <a:ext cx="163506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Gal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213" name="Google Shape;132;p1">
                <a:extLst>
                  <a:ext uri="{FF2B5EF4-FFF2-40B4-BE49-F238E27FC236}">
                    <a16:creationId xmlns:a16="http://schemas.microsoft.com/office/drawing/2014/main" xmlns="" id="{6E19693F-54CE-217F-B722-95A4A5A2A771}"/>
                  </a:ext>
                </a:extLst>
              </p:cNvPr>
              <p:cNvSpPr txBox="1"/>
              <p:nvPr/>
            </p:nvSpPr>
            <p:spPr>
              <a:xfrm>
                <a:off x="8939211" y="1711250"/>
                <a:ext cx="17472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Fu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cxnSp>
            <p:nvCxnSpPr>
              <p:cNvPr id="214" name="Google Shape;133;p1">
                <a:extLst>
                  <a:ext uri="{FF2B5EF4-FFF2-40B4-BE49-F238E27FC236}">
                    <a16:creationId xmlns:a16="http://schemas.microsoft.com/office/drawing/2014/main" xmlns="" id="{AF8E683C-2C14-9B1F-BDAA-45BF66DE6AF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888027" y="4286770"/>
                <a:ext cx="1022754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15" name="Google Shape;135;p1">
                <a:extLst>
                  <a:ext uri="{FF2B5EF4-FFF2-40B4-BE49-F238E27FC236}">
                    <a16:creationId xmlns:a16="http://schemas.microsoft.com/office/drawing/2014/main" xmlns="" id="{023DDC72-A240-9811-DBDA-593D51680E1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888027" y="3061083"/>
                <a:ext cx="1022754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16" name="Google Shape;136;p1">
                <a:extLst>
                  <a:ext uri="{FF2B5EF4-FFF2-40B4-BE49-F238E27FC236}">
                    <a16:creationId xmlns:a16="http://schemas.microsoft.com/office/drawing/2014/main" xmlns="" id="{6C585116-8548-881E-C108-BD075126936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888027" y="2707613"/>
                <a:ext cx="1022754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17" name="Google Shape;137;p1">
                <a:extLst>
                  <a:ext uri="{FF2B5EF4-FFF2-40B4-BE49-F238E27FC236}">
                    <a16:creationId xmlns:a16="http://schemas.microsoft.com/office/drawing/2014/main" xmlns="" id="{B4B5A49E-3E01-2499-4288-788906D00AC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69000" y="2515216"/>
                <a:ext cx="741781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18" name="Google Shape;138;p1">
                <a:extLst>
                  <a:ext uri="{FF2B5EF4-FFF2-40B4-BE49-F238E27FC236}">
                    <a16:creationId xmlns:a16="http://schemas.microsoft.com/office/drawing/2014/main" xmlns="" id="{2BD46840-33E0-2059-052E-5BF25CB4505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434992" y="2144866"/>
                <a:ext cx="475789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19" name="Google Shape;139;p1">
                <a:extLst>
                  <a:ext uri="{FF2B5EF4-FFF2-40B4-BE49-F238E27FC236}">
                    <a16:creationId xmlns:a16="http://schemas.microsoft.com/office/drawing/2014/main" xmlns="" id="{CE3B8C60-2D3C-6CD1-643F-A5C57463D16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434992" y="853400"/>
                <a:ext cx="471640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20" name="Google Shape;140;p1">
                <a:extLst>
                  <a:ext uri="{FF2B5EF4-FFF2-40B4-BE49-F238E27FC236}">
                    <a16:creationId xmlns:a16="http://schemas.microsoft.com/office/drawing/2014/main" xmlns="" id="{9203E092-86C8-8034-A15C-FAED6405E9F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888027" y="1133173"/>
                <a:ext cx="1018605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21" name="Google Shape;141;p1">
                <a:extLst>
                  <a:ext uri="{FF2B5EF4-FFF2-40B4-BE49-F238E27FC236}">
                    <a16:creationId xmlns:a16="http://schemas.microsoft.com/office/drawing/2014/main" xmlns="" id="{3F4A7F76-0694-7F12-4CD8-8618F646840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434992" y="1623772"/>
                <a:ext cx="471640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222" name="Google Shape;144;p1">
                <a:extLst>
                  <a:ext uri="{FF2B5EF4-FFF2-40B4-BE49-F238E27FC236}">
                    <a16:creationId xmlns:a16="http://schemas.microsoft.com/office/drawing/2014/main" xmlns="" id="{1E07597F-E9A4-5998-7F3F-273705F7C782}"/>
                  </a:ext>
                </a:extLst>
              </p:cNvPr>
              <p:cNvSpPr txBox="1"/>
              <p:nvPr/>
            </p:nvSpPr>
            <p:spPr>
              <a:xfrm>
                <a:off x="1407798" y="4766995"/>
                <a:ext cx="836274" cy="2461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Markers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223" name="Google Shape;145;p1">
                <a:extLst>
                  <a:ext uri="{FF2B5EF4-FFF2-40B4-BE49-F238E27FC236}">
                    <a16:creationId xmlns:a16="http://schemas.microsoft.com/office/drawing/2014/main" xmlns="" id="{6F1C2C91-F981-2B63-58C5-ADE2CEF07BFF}"/>
                  </a:ext>
                </a:extLst>
              </p:cNvPr>
              <p:cNvSpPr/>
              <p:nvPr/>
            </p:nvSpPr>
            <p:spPr>
              <a:xfrm rot="16200000">
                <a:off x="1738307" y="4250619"/>
                <a:ext cx="175256" cy="83627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24" name="Google Shape;146;p1">
                <a:extLst>
                  <a:ext uri="{FF2B5EF4-FFF2-40B4-BE49-F238E27FC236}">
                    <a16:creationId xmlns:a16="http://schemas.microsoft.com/office/drawing/2014/main" xmlns="" id="{BB1BA066-699A-9ECD-94D1-512E8DF98B38}"/>
                  </a:ext>
                </a:extLst>
              </p:cNvPr>
              <p:cNvSpPr txBox="1"/>
              <p:nvPr/>
            </p:nvSpPr>
            <p:spPr>
              <a:xfrm>
                <a:off x="7777419" y="4766995"/>
                <a:ext cx="836274" cy="2461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Markers</a:t>
                </a:r>
                <a:endParaRPr sz="1000" kern="0">
                  <a:solidFill>
                    <a:srgbClr val="000000"/>
                  </a:solidFill>
                  <a:latin typeface="Arial Narrow" panose="020B0606020202030204" pitchFamily="34" charset="0"/>
                  <a:cs typeface="Arial"/>
                  <a:sym typeface="Arial"/>
                </a:endParaRPr>
              </a:p>
            </p:txBody>
          </p:sp>
          <p:sp>
            <p:nvSpPr>
              <p:cNvPr id="225" name="Google Shape;147;p1">
                <a:extLst>
                  <a:ext uri="{FF2B5EF4-FFF2-40B4-BE49-F238E27FC236}">
                    <a16:creationId xmlns:a16="http://schemas.microsoft.com/office/drawing/2014/main" xmlns="" id="{54EB64CA-CC86-9FCE-CBC9-5CB8C7922007}"/>
                  </a:ext>
                </a:extLst>
              </p:cNvPr>
              <p:cNvSpPr/>
              <p:nvPr/>
            </p:nvSpPr>
            <p:spPr>
              <a:xfrm rot="16200000">
                <a:off x="8107928" y="4250620"/>
                <a:ext cx="175256" cy="83627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cxnSp>
            <p:nvCxnSpPr>
              <p:cNvPr id="226" name="Google Shape;102;p1">
                <a:extLst>
                  <a:ext uri="{FF2B5EF4-FFF2-40B4-BE49-F238E27FC236}">
                    <a16:creationId xmlns:a16="http://schemas.microsoft.com/office/drawing/2014/main" xmlns="" id="{8ED59DD6-C490-3BC9-2C7F-3642DA34DF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2357" y="4319956"/>
                <a:ext cx="380426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27" name="Google Shape;104;p1">
                <a:extLst>
                  <a:ext uri="{FF2B5EF4-FFF2-40B4-BE49-F238E27FC236}">
                    <a16:creationId xmlns:a16="http://schemas.microsoft.com/office/drawing/2014/main" xmlns="" id="{6EAED022-78C5-396B-8359-873B584EFB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8258" y="2947284"/>
                <a:ext cx="384525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28" name="Google Shape;105;p1">
                <a:extLst>
                  <a:ext uri="{FF2B5EF4-FFF2-40B4-BE49-F238E27FC236}">
                    <a16:creationId xmlns:a16="http://schemas.microsoft.com/office/drawing/2014/main" xmlns="" id="{DBD2D394-0B49-AAC2-C567-0649BE7D15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8258" y="2590268"/>
                <a:ext cx="384525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29" name="Google Shape;106;p1">
                <a:extLst>
                  <a:ext uri="{FF2B5EF4-FFF2-40B4-BE49-F238E27FC236}">
                    <a16:creationId xmlns:a16="http://schemas.microsoft.com/office/drawing/2014/main" xmlns="" id="{8DD695E2-5051-5FF5-CB2C-877807B1DD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8258" y="2400298"/>
                <a:ext cx="665922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30" name="Google Shape;107;p1">
                <a:extLst>
                  <a:ext uri="{FF2B5EF4-FFF2-40B4-BE49-F238E27FC236}">
                    <a16:creationId xmlns:a16="http://schemas.microsoft.com/office/drawing/2014/main" xmlns="" id="{4D0B1A72-4C25-F231-316C-D86691E1B89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8259" y="2167550"/>
                <a:ext cx="934186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31" name="Google Shape;108;p1">
                <a:extLst>
                  <a:ext uri="{FF2B5EF4-FFF2-40B4-BE49-F238E27FC236}">
                    <a16:creationId xmlns:a16="http://schemas.microsoft.com/office/drawing/2014/main" xmlns="" id="{4F363B99-9FB8-B38D-97AA-87CCE7397CA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8258" y="907464"/>
                <a:ext cx="931728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32" name="Google Shape;109;p1">
                <a:extLst>
                  <a:ext uri="{FF2B5EF4-FFF2-40B4-BE49-F238E27FC236}">
                    <a16:creationId xmlns:a16="http://schemas.microsoft.com/office/drawing/2014/main" xmlns="" id="{B5E7D539-4BA5-0217-7FBA-134E4A59ED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8258" y="1161351"/>
                <a:ext cx="384525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33" name="Google Shape;110;p1">
                <a:extLst>
                  <a:ext uri="{FF2B5EF4-FFF2-40B4-BE49-F238E27FC236}">
                    <a16:creationId xmlns:a16="http://schemas.microsoft.com/office/drawing/2014/main" xmlns="" id="{0060B524-7D8A-8F58-AED5-BA098147E2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8258" y="1667202"/>
                <a:ext cx="385871" cy="0"/>
              </a:xfrm>
              <a:prstGeom prst="straightConnector1">
                <a:avLst/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234" name="Free-form: Shape 233">
                <a:extLst>
                  <a:ext uri="{FF2B5EF4-FFF2-40B4-BE49-F238E27FC236}">
                    <a16:creationId xmlns:a16="http://schemas.microsoft.com/office/drawing/2014/main" xmlns="" id="{F266C871-CF5B-B64C-CFE1-6F3DFA8989AD}"/>
                  </a:ext>
                </a:extLst>
              </p:cNvPr>
              <p:cNvSpPr/>
              <p:nvPr/>
            </p:nvSpPr>
            <p:spPr>
              <a:xfrm flipV="1">
                <a:off x="7883999" y="1521984"/>
                <a:ext cx="1018485" cy="183093"/>
              </a:xfrm>
              <a:custGeom>
                <a:avLst/>
                <a:gdLst>
                  <a:gd name="connsiteX0" fmla="*/ 996927 w 996927"/>
                  <a:gd name="connsiteY0" fmla="*/ 313603 h 313603"/>
                  <a:gd name="connsiteX1" fmla="*/ 0 w 996927"/>
                  <a:gd name="connsiteY1" fmla="*/ 313603 h 313603"/>
                  <a:gd name="connsiteX2" fmla="*/ 0 w 996927"/>
                  <a:gd name="connsiteY2" fmla="*/ 0 h 3136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96927" h="313603">
                    <a:moveTo>
                      <a:pt x="996927" y="313603"/>
                    </a:moveTo>
                    <a:lnTo>
                      <a:pt x="0" y="31360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flat" cmpd="sng" algn="ctr">
                <a:solidFill>
                  <a:srgbClr val="5B9BD5">
                    <a:shade val="15000"/>
                  </a:srgbClr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GB" sz="10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Arial Narrow" panose="020B0606020202030204" pitchFamily="34" charset="0"/>
                  <a:sym typeface="Arial"/>
                </a:endParaRPr>
              </a:p>
            </p:txBody>
          </p:sp>
          <p:sp>
            <p:nvSpPr>
              <p:cNvPr id="235" name="Free-form: Shape 234">
                <a:extLst>
                  <a:ext uri="{FF2B5EF4-FFF2-40B4-BE49-F238E27FC236}">
                    <a16:creationId xmlns:a16="http://schemas.microsoft.com/office/drawing/2014/main" xmlns="" id="{DF1265FC-08A2-DE83-3EC4-C5B926F60923}"/>
                  </a:ext>
                </a:extLst>
              </p:cNvPr>
              <p:cNvSpPr/>
              <p:nvPr/>
            </p:nvSpPr>
            <p:spPr>
              <a:xfrm>
                <a:off x="8169000" y="1725559"/>
                <a:ext cx="741781" cy="69551"/>
              </a:xfrm>
              <a:custGeom>
                <a:avLst/>
                <a:gdLst>
                  <a:gd name="connsiteX0" fmla="*/ 996927 w 996927"/>
                  <a:gd name="connsiteY0" fmla="*/ 313603 h 313603"/>
                  <a:gd name="connsiteX1" fmla="*/ 0 w 996927"/>
                  <a:gd name="connsiteY1" fmla="*/ 313603 h 313603"/>
                  <a:gd name="connsiteX2" fmla="*/ 0 w 996927"/>
                  <a:gd name="connsiteY2" fmla="*/ 0 h 3136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96927" h="313603">
                    <a:moveTo>
                      <a:pt x="996927" y="313603"/>
                    </a:moveTo>
                    <a:lnTo>
                      <a:pt x="0" y="31360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flat" cmpd="sng" algn="ctr">
                <a:solidFill>
                  <a:srgbClr val="5B9BD5">
                    <a:shade val="15000"/>
                  </a:srgbClr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GB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Arial Narrow" panose="020B0606020202030204" pitchFamily="34" charset="0"/>
                  <a:sym typeface="Arial"/>
                </a:endParaRPr>
              </a:p>
            </p:txBody>
          </p:sp>
          <p:sp>
            <p:nvSpPr>
              <p:cNvPr id="236" name="Free-form: Shape 235">
                <a:extLst>
                  <a:ext uri="{FF2B5EF4-FFF2-40B4-BE49-F238E27FC236}">
                    <a16:creationId xmlns:a16="http://schemas.microsoft.com/office/drawing/2014/main" xmlns="" id="{4749C81E-840E-59C9-F032-E010DA7239E1}"/>
                  </a:ext>
                </a:extLst>
              </p:cNvPr>
              <p:cNvSpPr/>
              <p:nvPr/>
            </p:nvSpPr>
            <p:spPr>
              <a:xfrm flipV="1">
                <a:off x="8166985" y="4144565"/>
                <a:ext cx="743796" cy="68344"/>
              </a:xfrm>
              <a:custGeom>
                <a:avLst/>
                <a:gdLst>
                  <a:gd name="connsiteX0" fmla="*/ 996927 w 996927"/>
                  <a:gd name="connsiteY0" fmla="*/ 313603 h 313603"/>
                  <a:gd name="connsiteX1" fmla="*/ 0 w 996927"/>
                  <a:gd name="connsiteY1" fmla="*/ 313603 h 313603"/>
                  <a:gd name="connsiteX2" fmla="*/ 0 w 996927"/>
                  <a:gd name="connsiteY2" fmla="*/ 0 h 3136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96927" h="313603">
                    <a:moveTo>
                      <a:pt x="996927" y="313603"/>
                    </a:moveTo>
                    <a:lnTo>
                      <a:pt x="0" y="31360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flat" cmpd="sng" algn="ctr">
                <a:solidFill>
                  <a:srgbClr val="5B9BD5">
                    <a:shade val="15000"/>
                  </a:srgbClr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GB" sz="10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Arial Narrow" panose="020B0606020202030204" pitchFamily="34" charset="0"/>
                  <a:sym typeface="Arial"/>
                </a:endParaRPr>
              </a:p>
            </p:txBody>
          </p:sp>
          <p:sp>
            <p:nvSpPr>
              <p:cNvPr id="237" name="Free-form: Shape 236">
                <a:extLst>
                  <a:ext uri="{FF2B5EF4-FFF2-40B4-BE49-F238E27FC236}">
                    <a16:creationId xmlns:a16="http://schemas.microsoft.com/office/drawing/2014/main" xmlns="" id="{EED77E3C-1AFE-243D-7F07-E9DC23ECC375}"/>
                  </a:ext>
                </a:extLst>
              </p:cNvPr>
              <p:cNvSpPr/>
              <p:nvPr/>
            </p:nvSpPr>
            <p:spPr>
              <a:xfrm flipH="1" flipV="1">
                <a:off x="1112357" y="1551194"/>
                <a:ext cx="934187" cy="106138"/>
              </a:xfrm>
              <a:custGeom>
                <a:avLst/>
                <a:gdLst>
                  <a:gd name="connsiteX0" fmla="*/ 996927 w 996927"/>
                  <a:gd name="connsiteY0" fmla="*/ 313603 h 313603"/>
                  <a:gd name="connsiteX1" fmla="*/ 0 w 996927"/>
                  <a:gd name="connsiteY1" fmla="*/ 313603 h 313603"/>
                  <a:gd name="connsiteX2" fmla="*/ 0 w 996927"/>
                  <a:gd name="connsiteY2" fmla="*/ 0 h 3136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96927" h="313603">
                    <a:moveTo>
                      <a:pt x="996927" y="313603"/>
                    </a:moveTo>
                    <a:lnTo>
                      <a:pt x="0" y="31360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flat" cmpd="sng" algn="ctr">
                <a:solidFill>
                  <a:srgbClr val="5B9BD5">
                    <a:shade val="15000"/>
                  </a:srgbClr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GB" sz="10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Arial Narrow" panose="020B0606020202030204" pitchFamily="34" charset="0"/>
                  <a:sym typeface="Arial"/>
                </a:endParaRPr>
              </a:p>
            </p:txBody>
          </p:sp>
          <p:sp>
            <p:nvSpPr>
              <p:cNvPr id="238" name="Free-form: Shape 237">
                <a:extLst>
                  <a:ext uri="{FF2B5EF4-FFF2-40B4-BE49-F238E27FC236}">
                    <a16:creationId xmlns:a16="http://schemas.microsoft.com/office/drawing/2014/main" xmlns="" id="{1DE18ED0-F18E-6F80-0767-1E8E9AE64EDA}"/>
                  </a:ext>
                </a:extLst>
              </p:cNvPr>
              <p:cNvSpPr/>
              <p:nvPr/>
            </p:nvSpPr>
            <p:spPr>
              <a:xfrm flipH="1">
                <a:off x="1113302" y="1715519"/>
                <a:ext cx="660878" cy="82069"/>
              </a:xfrm>
              <a:custGeom>
                <a:avLst/>
                <a:gdLst>
                  <a:gd name="connsiteX0" fmla="*/ 996927 w 996927"/>
                  <a:gd name="connsiteY0" fmla="*/ 313603 h 313603"/>
                  <a:gd name="connsiteX1" fmla="*/ 0 w 996927"/>
                  <a:gd name="connsiteY1" fmla="*/ 313603 h 313603"/>
                  <a:gd name="connsiteX2" fmla="*/ 0 w 996927"/>
                  <a:gd name="connsiteY2" fmla="*/ 0 h 3136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96927" h="313603">
                    <a:moveTo>
                      <a:pt x="996927" y="313603"/>
                    </a:moveTo>
                    <a:lnTo>
                      <a:pt x="0" y="31360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flat" cmpd="sng" algn="ctr">
                <a:solidFill>
                  <a:srgbClr val="5B9BD5">
                    <a:shade val="15000"/>
                  </a:srgbClr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GB" sz="10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Arial Narrow" panose="020B0606020202030204" pitchFamily="34" charset="0"/>
                  <a:sym typeface="Arial"/>
                </a:endParaRPr>
              </a:p>
            </p:txBody>
          </p:sp>
          <p:sp>
            <p:nvSpPr>
              <p:cNvPr id="239" name="Free-form: Shape 238">
                <a:extLst>
                  <a:ext uri="{FF2B5EF4-FFF2-40B4-BE49-F238E27FC236}">
                    <a16:creationId xmlns:a16="http://schemas.microsoft.com/office/drawing/2014/main" xmlns="" id="{3C2089BD-8B44-9E9D-7E98-FEDAE12AC986}"/>
                  </a:ext>
                </a:extLst>
              </p:cNvPr>
              <p:cNvSpPr/>
              <p:nvPr/>
            </p:nvSpPr>
            <p:spPr>
              <a:xfrm flipH="1" flipV="1">
                <a:off x="1112353" y="4159349"/>
                <a:ext cx="686470" cy="70023"/>
              </a:xfrm>
              <a:custGeom>
                <a:avLst/>
                <a:gdLst>
                  <a:gd name="connsiteX0" fmla="*/ 996927 w 996927"/>
                  <a:gd name="connsiteY0" fmla="*/ 313603 h 313603"/>
                  <a:gd name="connsiteX1" fmla="*/ 0 w 996927"/>
                  <a:gd name="connsiteY1" fmla="*/ 313603 h 313603"/>
                  <a:gd name="connsiteX2" fmla="*/ 0 w 996927"/>
                  <a:gd name="connsiteY2" fmla="*/ 0 h 3136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96927" h="313603">
                    <a:moveTo>
                      <a:pt x="996927" y="313603"/>
                    </a:moveTo>
                    <a:lnTo>
                      <a:pt x="0" y="31360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flat" cmpd="sng" algn="ctr">
                <a:solidFill>
                  <a:srgbClr val="5B9BD5">
                    <a:shade val="15000"/>
                  </a:srgbClr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GB" sz="10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Arial Narrow" panose="020B0606020202030204" pitchFamily="34" charset="0"/>
                  <a:sym typeface="Arial"/>
                </a:endParaRPr>
              </a:p>
            </p:txBody>
          </p:sp>
          <p:sp>
            <p:nvSpPr>
              <p:cNvPr id="244" name="Google Shape;94;p1">
                <a:extLst>
                  <a:ext uri="{FF2B5EF4-FFF2-40B4-BE49-F238E27FC236}">
                    <a16:creationId xmlns:a16="http://schemas.microsoft.com/office/drawing/2014/main" xmlns="" id="{F6BE61DE-83AF-81A2-C421-114986CC26EA}"/>
                  </a:ext>
                </a:extLst>
              </p:cNvPr>
              <p:cNvSpPr txBox="1"/>
              <p:nvPr/>
            </p:nvSpPr>
            <p:spPr>
              <a:xfrm>
                <a:off x="2327237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45" name="Google Shape;94;p1">
                <a:extLst>
                  <a:ext uri="{FF2B5EF4-FFF2-40B4-BE49-F238E27FC236}">
                    <a16:creationId xmlns:a16="http://schemas.microsoft.com/office/drawing/2014/main" xmlns="" id="{B18DBA2C-7871-7947-DF78-D92B06CE605C}"/>
                  </a:ext>
                </a:extLst>
              </p:cNvPr>
              <p:cNvSpPr txBox="1"/>
              <p:nvPr/>
            </p:nvSpPr>
            <p:spPr>
              <a:xfrm>
                <a:off x="2603082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46" name="Google Shape;94;p1">
                <a:extLst>
                  <a:ext uri="{FF2B5EF4-FFF2-40B4-BE49-F238E27FC236}">
                    <a16:creationId xmlns:a16="http://schemas.microsoft.com/office/drawing/2014/main" xmlns="" id="{C223A2EB-862F-4B87-D7CC-E165FA05FF1F}"/>
                  </a:ext>
                </a:extLst>
              </p:cNvPr>
              <p:cNvSpPr txBox="1"/>
              <p:nvPr/>
            </p:nvSpPr>
            <p:spPr>
              <a:xfrm>
                <a:off x="2910585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47" name="Google Shape;94;p1">
                <a:extLst>
                  <a:ext uri="{FF2B5EF4-FFF2-40B4-BE49-F238E27FC236}">
                    <a16:creationId xmlns:a16="http://schemas.microsoft.com/office/drawing/2014/main" xmlns="" id="{6985AE86-9EF7-4653-3C71-0B7294CE8E60}"/>
                  </a:ext>
                </a:extLst>
              </p:cNvPr>
              <p:cNvSpPr txBox="1"/>
              <p:nvPr/>
            </p:nvSpPr>
            <p:spPr>
              <a:xfrm>
                <a:off x="3186430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48" name="Google Shape;94;p1">
                <a:extLst>
                  <a:ext uri="{FF2B5EF4-FFF2-40B4-BE49-F238E27FC236}">
                    <a16:creationId xmlns:a16="http://schemas.microsoft.com/office/drawing/2014/main" xmlns="" id="{E628820C-2D1F-0C97-0698-7A9BDDACCA8D}"/>
                  </a:ext>
                </a:extLst>
              </p:cNvPr>
              <p:cNvSpPr txBox="1"/>
              <p:nvPr/>
            </p:nvSpPr>
            <p:spPr>
              <a:xfrm>
                <a:off x="3508120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49" name="Google Shape;94;p1">
                <a:extLst>
                  <a:ext uri="{FF2B5EF4-FFF2-40B4-BE49-F238E27FC236}">
                    <a16:creationId xmlns:a16="http://schemas.microsoft.com/office/drawing/2014/main" xmlns="" id="{8BFADE8F-8E8F-8ECE-6594-28A5D8B5631E}"/>
                  </a:ext>
                </a:extLst>
              </p:cNvPr>
              <p:cNvSpPr txBox="1"/>
              <p:nvPr/>
            </p:nvSpPr>
            <p:spPr>
              <a:xfrm>
                <a:off x="3783965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0" name="Google Shape;94;p1">
                <a:extLst>
                  <a:ext uri="{FF2B5EF4-FFF2-40B4-BE49-F238E27FC236}">
                    <a16:creationId xmlns:a16="http://schemas.microsoft.com/office/drawing/2014/main" xmlns="" id="{EEF23619-6664-F38B-76DC-DA51F35B50EE}"/>
                  </a:ext>
                </a:extLst>
              </p:cNvPr>
              <p:cNvSpPr txBox="1"/>
              <p:nvPr/>
            </p:nvSpPr>
            <p:spPr>
              <a:xfrm>
                <a:off x="2445304" y="4861097"/>
                <a:ext cx="23403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1" name="Google Shape;94;p1">
                <a:extLst>
                  <a:ext uri="{FF2B5EF4-FFF2-40B4-BE49-F238E27FC236}">
                    <a16:creationId xmlns:a16="http://schemas.microsoft.com/office/drawing/2014/main" xmlns="" id="{3076F54E-3AB1-5052-A778-3516212220E6}"/>
                  </a:ext>
                </a:extLst>
              </p:cNvPr>
              <p:cNvSpPr txBox="1"/>
              <p:nvPr/>
            </p:nvSpPr>
            <p:spPr>
              <a:xfrm>
                <a:off x="3020689" y="4852713"/>
                <a:ext cx="234039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6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2" name="Google Shape;94;p1">
                <a:extLst>
                  <a:ext uri="{FF2B5EF4-FFF2-40B4-BE49-F238E27FC236}">
                    <a16:creationId xmlns:a16="http://schemas.microsoft.com/office/drawing/2014/main" xmlns="" id="{B074A79E-0874-9C84-F737-562AC8F06AB0}"/>
                  </a:ext>
                </a:extLst>
              </p:cNvPr>
              <p:cNvSpPr txBox="1"/>
              <p:nvPr/>
            </p:nvSpPr>
            <p:spPr>
              <a:xfrm>
                <a:off x="3595702" y="4852713"/>
                <a:ext cx="29174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0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3" name="Google Shape;145;p1">
                <a:extLst>
                  <a:ext uri="{FF2B5EF4-FFF2-40B4-BE49-F238E27FC236}">
                    <a16:creationId xmlns:a16="http://schemas.microsoft.com/office/drawing/2014/main" xmlns="" id="{71CA49DD-8473-45DB-843A-567158053D8A}"/>
                  </a:ext>
                </a:extLst>
              </p:cNvPr>
              <p:cNvSpPr/>
              <p:nvPr/>
            </p:nvSpPr>
            <p:spPr>
              <a:xfrm rot="16200000">
                <a:off x="2504609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4" name="Google Shape;145;p1">
                <a:extLst>
                  <a:ext uri="{FF2B5EF4-FFF2-40B4-BE49-F238E27FC236}">
                    <a16:creationId xmlns:a16="http://schemas.microsoft.com/office/drawing/2014/main" xmlns="" id="{39C85152-3C84-7694-8760-49C33206473F}"/>
                  </a:ext>
                </a:extLst>
              </p:cNvPr>
              <p:cNvSpPr/>
              <p:nvPr/>
            </p:nvSpPr>
            <p:spPr>
              <a:xfrm rot="16200000">
                <a:off x="3102229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5" name="Google Shape;145;p1">
                <a:extLst>
                  <a:ext uri="{FF2B5EF4-FFF2-40B4-BE49-F238E27FC236}">
                    <a16:creationId xmlns:a16="http://schemas.microsoft.com/office/drawing/2014/main" xmlns="" id="{6AECD08A-9945-6B46-4B73-E77BEAA66FF7}"/>
                  </a:ext>
                </a:extLst>
              </p:cNvPr>
              <p:cNvSpPr/>
              <p:nvPr/>
            </p:nvSpPr>
            <p:spPr>
              <a:xfrm rot="16200000">
                <a:off x="3694960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6" name="Google Shape;94;p1">
                <a:extLst>
                  <a:ext uri="{FF2B5EF4-FFF2-40B4-BE49-F238E27FC236}">
                    <a16:creationId xmlns:a16="http://schemas.microsoft.com/office/drawing/2014/main" xmlns="" id="{CC84C65A-1B9A-AC72-C9CD-003FEC11EE42}"/>
                  </a:ext>
                </a:extLst>
              </p:cNvPr>
              <p:cNvSpPr txBox="1"/>
              <p:nvPr/>
            </p:nvSpPr>
            <p:spPr>
              <a:xfrm>
                <a:off x="4254786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7" name="Google Shape;94;p1">
                <a:extLst>
                  <a:ext uri="{FF2B5EF4-FFF2-40B4-BE49-F238E27FC236}">
                    <a16:creationId xmlns:a16="http://schemas.microsoft.com/office/drawing/2014/main" xmlns="" id="{C44150D8-F170-9906-7C41-EF58938DCD9B}"/>
                  </a:ext>
                </a:extLst>
              </p:cNvPr>
              <p:cNvSpPr txBox="1"/>
              <p:nvPr/>
            </p:nvSpPr>
            <p:spPr>
              <a:xfrm>
                <a:off x="4530631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8" name="Google Shape;94;p1">
                <a:extLst>
                  <a:ext uri="{FF2B5EF4-FFF2-40B4-BE49-F238E27FC236}">
                    <a16:creationId xmlns:a16="http://schemas.microsoft.com/office/drawing/2014/main" xmlns="" id="{55E89C04-5402-3635-2C46-D5E1769167B2}"/>
                  </a:ext>
                </a:extLst>
              </p:cNvPr>
              <p:cNvSpPr txBox="1"/>
              <p:nvPr/>
            </p:nvSpPr>
            <p:spPr>
              <a:xfrm>
                <a:off x="4838134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59" name="Google Shape;94;p1">
                <a:extLst>
                  <a:ext uri="{FF2B5EF4-FFF2-40B4-BE49-F238E27FC236}">
                    <a16:creationId xmlns:a16="http://schemas.microsoft.com/office/drawing/2014/main" xmlns="" id="{719D3B26-2458-BD01-90E3-2FC7E52C38B1}"/>
                  </a:ext>
                </a:extLst>
              </p:cNvPr>
              <p:cNvSpPr txBox="1"/>
              <p:nvPr/>
            </p:nvSpPr>
            <p:spPr>
              <a:xfrm>
                <a:off x="5113979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0" name="Google Shape;94;p1">
                <a:extLst>
                  <a:ext uri="{FF2B5EF4-FFF2-40B4-BE49-F238E27FC236}">
                    <a16:creationId xmlns:a16="http://schemas.microsoft.com/office/drawing/2014/main" xmlns="" id="{66F9A7C2-4E30-0DD7-151C-A3AD208B5EC6}"/>
                  </a:ext>
                </a:extLst>
              </p:cNvPr>
              <p:cNvSpPr txBox="1"/>
              <p:nvPr/>
            </p:nvSpPr>
            <p:spPr>
              <a:xfrm>
                <a:off x="5435669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1" name="Google Shape;94;p1">
                <a:extLst>
                  <a:ext uri="{FF2B5EF4-FFF2-40B4-BE49-F238E27FC236}">
                    <a16:creationId xmlns:a16="http://schemas.microsoft.com/office/drawing/2014/main" xmlns="" id="{D6F449CA-F667-9F7E-43A3-60AAE133E803}"/>
                  </a:ext>
                </a:extLst>
              </p:cNvPr>
              <p:cNvSpPr txBox="1"/>
              <p:nvPr/>
            </p:nvSpPr>
            <p:spPr>
              <a:xfrm>
                <a:off x="5711514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2" name="Google Shape;94;p1">
                <a:extLst>
                  <a:ext uri="{FF2B5EF4-FFF2-40B4-BE49-F238E27FC236}">
                    <a16:creationId xmlns:a16="http://schemas.microsoft.com/office/drawing/2014/main" xmlns="" id="{8753B4E3-7513-B735-4D99-CF57E17E816C}"/>
                  </a:ext>
                </a:extLst>
              </p:cNvPr>
              <p:cNvSpPr txBox="1"/>
              <p:nvPr/>
            </p:nvSpPr>
            <p:spPr>
              <a:xfrm>
                <a:off x="4372853" y="4861097"/>
                <a:ext cx="23403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3" name="Google Shape;94;p1">
                <a:extLst>
                  <a:ext uri="{FF2B5EF4-FFF2-40B4-BE49-F238E27FC236}">
                    <a16:creationId xmlns:a16="http://schemas.microsoft.com/office/drawing/2014/main" xmlns="" id="{F3648E7B-41BE-64BA-C693-99296995833D}"/>
                  </a:ext>
                </a:extLst>
              </p:cNvPr>
              <p:cNvSpPr txBox="1"/>
              <p:nvPr/>
            </p:nvSpPr>
            <p:spPr>
              <a:xfrm>
                <a:off x="4948238" y="4852713"/>
                <a:ext cx="234039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6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4" name="Google Shape;94;p1">
                <a:extLst>
                  <a:ext uri="{FF2B5EF4-FFF2-40B4-BE49-F238E27FC236}">
                    <a16:creationId xmlns:a16="http://schemas.microsoft.com/office/drawing/2014/main" xmlns="" id="{A643F43C-D031-4F9F-3AE1-10BB532F25D8}"/>
                  </a:ext>
                </a:extLst>
              </p:cNvPr>
              <p:cNvSpPr txBox="1"/>
              <p:nvPr/>
            </p:nvSpPr>
            <p:spPr>
              <a:xfrm>
                <a:off x="5523251" y="4852713"/>
                <a:ext cx="29174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0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5" name="Google Shape;145;p1">
                <a:extLst>
                  <a:ext uri="{FF2B5EF4-FFF2-40B4-BE49-F238E27FC236}">
                    <a16:creationId xmlns:a16="http://schemas.microsoft.com/office/drawing/2014/main" xmlns="" id="{0276835B-4E93-F428-D535-2DED1702FD76}"/>
                  </a:ext>
                </a:extLst>
              </p:cNvPr>
              <p:cNvSpPr/>
              <p:nvPr/>
            </p:nvSpPr>
            <p:spPr>
              <a:xfrm rot="16200000">
                <a:off x="4432158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6" name="Google Shape;145;p1">
                <a:extLst>
                  <a:ext uri="{FF2B5EF4-FFF2-40B4-BE49-F238E27FC236}">
                    <a16:creationId xmlns:a16="http://schemas.microsoft.com/office/drawing/2014/main" xmlns="" id="{0B114DC2-B41B-DC06-431E-E543B7D18DFE}"/>
                  </a:ext>
                </a:extLst>
              </p:cNvPr>
              <p:cNvSpPr/>
              <p:nvPr/>
            </p:nvSpPr>
            <p:spPr>
              <a:xfrm rot="16200000">
                <a:off x="5029778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7" name="Google Shape;145;p1">
                <a:extLst>
                  <a:ext uri="{FF2B5EF4-FFF2-40B4-BE49-F238E27FC236}">
                    <a16:creationId xmlns:a16="http://schemas.microsoft.com/office/drawing/2014/main" xmlns="" id="{DF5F621F-F7CE-4785-67DC-3B82675D1535}"/>
                  </a:ext>
                </a:extLst>
              </p:cNvPr>
              <p:cNvSpPr/>
              <p:nvPr/>
            </p:nvSpPr>
            <p:spPr>
              <a:xfrm rot="16200000">
                <a:off x="5622509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8" name="Google Shape;94;p1">
                <a:extLst>
                  <a:ext uri="{FF2B5EF4-FFF2-40B4-BE49-F238E27FC236}">
                    <a16:creationId xmlns:a16="http://schemas.microsoft.com/office/drawing/2014/main" xmlns="" id="{8222611B-D5E4-6581-19C6-F2D94264F808}"/>
                  </a:ext>
                </a:extLst>
              </p:cNvPr>
              <p:cNvSpPr txBox="1"/>
              <p:nvPr/>
            </p:nvSpPr>
            <p:spPr>
              <a:xfrm>
                <a:off x="6052349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69" name="Google Shape;94;p1">
                <a:extLst>
                  <a:ext uri="{FF2B5EF4-FFF2-40B4-BE49-F238E27FC236}">
                    <a16:creationId xmlns:a16="http://schemas.microsoft.com/office/drawing/2014/main" xmlns="" id="{1251547E-D89D-5770-3D64-6DFD52BED1A0}"/>
                  </a:ext>
                </a:extLst>
              </p:cNvPr>
              <p:cNvSpPr txBox="1"/>
              <p:nvPr/>
            </p:nvSpPr>
            <p:spPr>
              <a:xfrm>
                <a:off x="6328194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0" name="Google Shape;94;p1">
                <a:extLst>
                  <a:ext uri="{FF2B5EF4-FFF2-40B4-BE49-F238E27FC236}">
                    <a16:creationId xmlns:a16="http://schemas.microsoft.com/office/drawing/2014/main" xmlns="" id="{74CBF90E-6675-2312-634F-8FAEA54E392A}"/>
                  </a:ext>
                </a:extLst>
              </p:cNvPr>
              <p:cNvSpPr txBox="1"/>
              <p:nvPr/>
            </p:nvSpPr>
            <p:spPr>
              <a:xfrm>
                <a:off x="6635697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1" name="Google Shape;94;p1">
                <a:extLst>
                  <a:ext uri="{FF2B5EF4-FFF2-40B4-BE49-F238E27FC236}">
                    <a16:creationId xmlns:a16="http://schemas.microsoft.com/office/drawing/2014/main" xmlns="" id="{8E9DA226-7056-5415-3267-680AD6374D8B}"/>
                  </a:ext>
                </a:extLst>
              </p:cNvPr>
              <p:cNvSpPr txBox="1"/>
              <p:nvPr/>
            </p:nvSpPr>
            <p:spPr>
              <a:xfrm>
                <a:off x="6911542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2" name="Google Shape;94;p1">
                <a:extLst>
                  <a:ext uri="{FF2B5EF4-FFF2-40B4-BE49-F238E27FC236}">
                    <a16:creationId xmlns:a16="http://schemas.microsoft.com/office/drawing/2014/main" xmlns="" id="{3864016F-A100-69C9-03AA-EBDCBF0C5EE8}"/>
                  </a:ext>
                </a:extLst>
              </p:cNvPr>
              <p:cNvSpPr txBox="1"/>
              <p:nvPr/>
            </p:nvSpPr>
            <p:spPr>
              <a:xfrm>
                <a:off x="7233232" y="4581128"/>
                <a:ext cx="144271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3" name="Google Shape;94;p1">
                <a:extLst>
                  <a:ext uri="{FF2B5EF4-FFF2-40B4-BE49-F238E27FC236}">
                    <a16:creationId xmlns:a16="http://schemas.microsoft.com/office/drawing/2014/main" xmlns="" id="{31E6062A-A28B-06EB-4E57-8DC1BD869852}"/>
                  </a:ext>
                </a:extLst>
              </p:cNvPr>
              <p:cNvSpPr txBox="1"/>
              <p:nvPr/>
            </p:nvSpPr>
            <p:spPr>
              <a:xfrm>
                <a:off x="7509077" y="4581128"/>
                <a:ext cx="20197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6 h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4" name="Google Shape;94;p1">
                <a:extLst>
                  <a:ext uri="{FF2B5EF4-FFF2-40B4-BE49-F238E27FC236}">
                    <a16:creationId xmlns:a16="http://schemas.microsoft.com/office/drawing/2014/main" xmlns="" id="{FFBAF78E-6CDD-5CF0-2126-56BF8A952FED}"/>
                  </a:ext>
                </a:extLst>
              </p:cNvPr>
              <p:cNvSpPr txBox="1"/>
              <p:nvPr/>
            </p:nvSpPr>
            <p:spPr>
              <a:xfrm>
                <a:off x="6170416" y="4861097"/>
                <a:ext cx="23403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2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5" name="Google Shape;94;p1">
                <a:extLst>
                  <a:ext uri="{FF2B5EF4-FFF2-40B4-BE49-F238E27FC236}">
                    <a16:creationId xmlns:a16="http://schemas.microsoft.com/office/drawing/2014/main" xmlns="" id="{5CAA3AAB-AD9C-6B54-60D3-781C99AB69E7}"/>
                  </a:ext>
                </a:extLst>
              </p:cNvPr>
              <p:cNvSpPr txBox="1"/>
              <p:nvPr/>
            </p:nvSpPr>
            <p:spPr>
              <a:xfrm>
                <a:off x="6745801" y="4852713"/>
                <a:ext cx="234039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6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6" name="Google Shape;94;p1">
                <a:extLst>
                  <a:ext uri="{FF2B5EF4-FFF2-40B4-BE49-F238E27FC236}">
                    <a16:creationId xmlns:a16="http://schemas.microsoft.com/office/drawing/2014/main" xmlns="" id="{244D7820-ED55-710B-902B-8FB2C74BE483}"/>
                  </a:ext>
                </a:extLst>
              </p:cNvPr>
              <p:cNvSpPr txBox="1"/>
              <p:nvPr/>
            </p:nvSpPr>
            <p:spPr>
              <a:xfrm>
                <a:off x="7320814" y="4852713"/>
                <a:ext cx="291748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none" lIns="0" tIns="0" rIns="0" bIns="0" anchor="t" anchorCtr="0">
                <a:spAutoFit/>
              </a:bodyPr>
              <a:lstStyle/>
              <a:p>
                <a:pPr algn="ctr">
                  <a:buClr>
                    <a:srgbClr val="000000"/>
                  </a:buClr>
                  <a:buFont typeface="Arial"/>
                  <a:buNone/>
                </a:pPr>
                <a:r>
                  <a:rPr lang="en-GB" sz="1000" kern="0" dirty="0">
                    <a:solidFill>
                      <a:srgbClr val="000000"/>
                    </a:solidFill>
                    <a:latin typeface="Arial Narrow" panose="020B0606020202030204" pitchFamily="34" charset="0"/>
                    <a:ea typeface="Calibri"/>
                    <a:cs typeface="Calibri"/>
                    <a:sym typeface="Calibri"/>
                  </a:rPr>
                  <a:t>100°C</a:t>
                </a:r>
                <a:endParaRPr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7" name="Google Shape;145;p1">
                <a:extLst>
                  <a:ext uri="{FF2B5EF4-FFF2-40B4-BE49-F238E27FC236}">
                    <a16:creationId xmlns:a16="http://schemas.microsoft.com/office/drawing/2014/main" xmlns="" id="{077F74DB-61ED-4E88-3B12-69000A8EDF86}"/>
                  </a:ext>
                </a:extLst>
              </p:cNvPr>
              <p:cNvSpPr/>
              <p:nvPr/>
            </p:nvSpPr>
            <p:spPr>
              <a:xfrm rot="16200000">
                <a:off x="6229721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8" name="Google Shape;145;p1">
                <a:extLst>
                  <a:ext uri="{FF2B5EF4-FFF2-40B4-BE49-F238E27FC236}">
                    <a16:creationId xmlns:a16="http://schemas.microsoft.com/office/drawing/2014/main" xmlns="" id="{4F068C1F-8AC2-663A-CCC0-BBED01750408}"/>
                  </a:ext>
                </a:extLst>
              </p:cNvPr>
              <p:cNvSpPr/>
              <p:nvPr/>
            </p:nvSpPr>
            <p:spPr>
              <a:xfrm rot="16200000">
                <a:off x="6827341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279" name="Google Shape;145;p1">
                <a:extLst>
                  <a:ext uri="{FF2B5EF4-FFF2-40B4-BE49-F238E27FC236}">
                    <a16:creationId xmlns:a16="http://schemas.microsoft.com/office/drawing/2014/main" xmlns="" id="{34C2640E-BDB1-5A97-440C-EA3C7E6A5427}"/>
                  </a:ext>
                </a:extLst>
              </p:cNvPr>
              <p:cNvSpPr/>
              <p:nvPr/>
            </p:nvSpPr>
            <p:spPr>
              <a:xfrm rot="16200000">
                <a:off x="7420072" y="4520742"/>
                <a:ext cx="117186" cy="545734"/>
              </a:xfrm>
              <a:prstGeom prst="leftBrace">
                <a:avLst>
                  <a:gd name="adj1" fmla="val 8333"/>
                  <a:gd name="adj2" fmla="val 50000"/>
                </a:avLst>
              </a:prstGeom>
              <a:noFill/>
              <a:ln w="9525" cap="flat" cmpd="sng">
                <a:solidFill>
                  <a:srgbClr val="00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10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Narrow" panose="020B0606020202030204" pitchFamily="34" charset="0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292" name="Google Shape;122;p1">
              <a:extLst>
                <a:ext uri="{FF2B5EF4-FFF2-40B4-BE49-F238E27FC236}">
                  <a16:creationId xmlns:a16="http://schemas.microsoft.com/office/drawing/2014/main" xmlns="" id="{D1D5D5E9-B8AF-2319-8727-35A1BEEED7BB}"/>
                </a:ext>
              </a:extLst>
            </p:cNvPr>
            <p:cNvSpPr txBox="1"/>
            <p:nvPr/>
          </p:nvSpPr>
          <p:spPr>
            <a:xfrm>
              <a:off x="8753178" y="471910"/>
              <a:ext cx="487313" cy="15388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none" lIns="0" tIns="0" rIns="0" bIns="0" anchor="t" anchorCtr="0">
              <a:spAutoFit/>
            </a:bodyPr>
            <a:lstStyle/>
            <a:p>
              <a:pPr>
                <a:buClr>
                  <a:srgbClr val="000000"/>
                </a:buClr>
                <a:buFont typeface="Arial"/>
                <a:buNone/>
              </a:pPr>
              <a:r>
                <a:rPr lang="en-GB" sz="1000" kern="0" dirty="0">
                  <a:solidFill>
                    <a:schemeClr val="bg1">
                      <a:lumMod val="50000"/>
                    </a:schemeClr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rPr>
                <a:t>Unknowns</a:t>
              </a:r>
              <a:endParaRPr sz="1000" kern="0" dirty="0">
                <a:solidFill>
                  <a:schemeClr val="bg1">
                    <a:lumMod val="50000"/>
                  </a:schemeClr>
                </a:solidFill>
                <a:latin typeface="Arial Narrow" panose="020B0606020202030204" pitchFamily="34" charset="0"/>
                <a:ea typeface="Calibri"/>
                <a:cs typeface="Calibri"/>
                <a:sym typeface="Calibri"/>
              </a:endParaRPr>
            </a:p>
          </p:txBody>
        </p:sp>
        <p:grpSp>
          <p:nvGrpSpPr>
            <p:cNvPr id="303" name="Group 302">
              <a:extLst>
                <a:ext uri="{FF2B5EF4-FFF2-40B4-BE49-F238E27FC236}">
                  <a16:creationId xmlns:a16="http://schemas.microsoft.com/office/drawing/2014/main" xmlns="" id="{8C4B219E-2DA5-B2BA-85A6-83180F027279}"/>
                </a:ext>
              </a:extLst>
            </p:cNvPr>
            <p:cNvGrpSpPr/>
            <p:nvPr/>
          </p:nvGrpSpPr>
          <p:grpSpPr>
            <a:xfrm>
              <a:off x="6933916" y="414188"/>
              <a:ext cx="1800200" cy="604636"/>
              <a:chOff x="7113240" y="414188"/>
              <a:chExt cx="1800200" cy="604636"/>
            </a:xfrm>
          </p:grpSpPr>
          <p:cxnSp>
            <p:nvCxnSpPr>
              <p:cNvPr id="281" name="Google Shape;140;p1">
                <a:extLst>
                  <a:ext uri="{FF2B5EF4-FFF2-40B4-BE49-F238E27FC236}">
                    <a16:creationId xmlns:a16="http://schemas.microsoft.com/office/drawing/2014/main" xmlns="" id="{CEB2DCFF-A3DE-4E74-7817-2EEB344382B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13240" y="416569"/>
                <a:ext cx="499322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tx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82" name="Google Shape;140;p1">
                <a:extLst>
                  <a:ext uri="{FF2B5EF4-FFF2-40B4-BE49-F238E27FC236}">
                    <a16:creationId xmlns:a16="http://schemas.microsoft.com/office/drawing/2014/main" xmlns="" id="{885739CB-59E0-24E5-8B90-F5D864A45CA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13240" y="549921"/>
                <a:ext cx="180020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tx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84" name="Google Shape;140;p1">
                <a:extLst>
                  <a:ext uri="{FF2B5EF4-FFF2-40B4-BE49-F238E27FC236}">
                    <a16:creationId xmlns:a16="http://schemas.microsoft.com/office/drawing/2014/main" xmlns="" id="{9FC13743-91F8-F243-7D4E-EE14DE67A0F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13240" y="764704"/>
                <a:ext cx="504056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tx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85" name="Google Shape;140;p1">
                <a:extLst>
                  <a:ext uri="{FF2B5EF4-FFF2-40B4-BE49-F238E27FC236}">
                    <a16:creationId xmlns:a16="http://schemas.microsoft.com/office/drawing/2014/main" xmlns="" id="{3B8105C7-B7BD-A13D-DC8A-EA06DA019A1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13240" y="1018824"/>
                <a:ext cx="499322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tx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297" name="Google Shape;140;p1">
                <a:extLst>
                  <a:ext uri="{FF2B5EF4-FFF2-40B4-BE49-F238E27FC236}">
                    <a16:creationId xmlns:a16="http://schemas.microsoft.com/office/drawing/2014/main" xmlns="" id="{5956FFCE-182E-BC14-F23A-8F5E60C14A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14915" y="414188"/>
                <a:ext cx="0" cy="604636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tx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</p:grpSp>
        <p:sp>
          <p:nvSpPr>
            <p:cNvPr id="301" name="Google Shape;132;p1">
              <a:extLst>
                <a:ext uri="{FF2B5EF4-FFF2-40B4-BE49-F238E27FC236}">
                  <a16:creationId xmlns:a16="http://schemas.microsoft.com/office/drawing/2014/main" xmlns="" id="{4725C147-FC45-F04C-AA66-32FB608EE0A5}"/>
                </a:ext>
              </a:extLst>
            </p:cNvPr>
            <p:cNvSpPr txBox="1"/>
            <p:nvPr/>
          </p:nvSpPr>
          <p:spPr>
            <a:xfrm>
              <a:off x="8758745" y="620688"/>
              <a:ext cx="601127" cy="15388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none" lIns="0" tIns="0" rIns="0" bIns="0" anchor="t" anchorCtr="0">
              <a:spAutoFit/>
            </a:bodyPr>
            <a:lstStyle/>
            <a:p>
              <a:pPr>
                <a:buClr>
                  <a:srgbClr val="000000"/>
                </a:buClr>
                <a:buFont typeface="Arial"/>
                <a:buNone/>
              </a:pPr>
              <a:r>
                <a:rPr lang="en-GB" sz="1000" kern="0" dirty="0">
                  <a:solidFill>
                    <a:srgbClr val="000000"/>
                  </a:solidFill>
                  <a:latin typeface="Arial Narrow" panose="020B0606020202030204" pitchFamily="34" charset="0"/>
                  <a:ea typeface="Calibri"/>
                  <a:cs typeface="Calibri"/>
                  <a:sym typeface="Calibri"/>
                </a:rPr>
                <a:t>GlcA-lactone</a:t>
              </a:r>
              <a:endParaRPr sz="1000" kern="0" dirty="0">
                <a:solidFill>
                  <a:srgbClr val="000000"/>
                </a:solidFill>
                <a:latin typeface="Arial Narrow" panose="020B0606020202030204" pitchFamily="34" charset="0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302" name="Free-form: Shape 301">
              <a:extLst>
                <a:ext uri="{FF2B5EF4-FFF2-40B4-BE49-F238E27FC236}">
                  <a16:creationId xmlns:a16="http://schemas.microsoft.com/office/drawing/2014/main" xmlns="" id="{6F039BAD-99CE-C6C7-A9B8-5FC5A14A1345}"/>
                </a:ext>
              </a:extLst>
            </p:cNvPr>
            <p:cNvSpPr/>
            <p:nvPr/>
          </p:nvSpPr>
          <p:spPr>
            <a:xfrm flipV="1">
              <a:off x="7921690" y="704548"/>
              <a:ext cx="808626" cy="138240"/>
            </a:xfrm>
            <a:custGeom>
              <a:avLst/>
              <a:gdLst>
                <a:gd name="connsiteX0" fmla="*/ 996927 w 996927"/>
                <a:gd name="connsiteY0" fmla="*/ 313603 h 313603"/>
                <a:gd name="connsiteX1" fmla="*/ 0 w 996927"/>
                <a:gd name="connsiteY1" fmla="*/ 313603 h 313603"/>
                <a:gd name="connsiteX2" fmla="*/ 0 w 996927"/>
                <a:gd name="connsiteY2" fmla="*/ 0 h 3136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96927" h="313603">
                  <a:moveTo>
                    <a:pt x="996927" y="313603"/>
                  </a:moveTo>
                  <a:lnTo>
                    <a:pt x="0" y="313603"/>
                  </a:lnTo>
                  <a:lnTo>
                    <a:pt x="0" y="0"/>
                  </a:lnTo>
                </a:path>
              </a:pathLst>
            </a:custGeom>
            <a:noFill/>
            <a:ln w="9525" cap="flat" cmpd="sng" algn="ctr">
              <a:solidFill>
                <a:srgbClr val="5B9BD5">
                  <a:shade val="15000"/>
                </a:srgb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lang="en-GB" sz="10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 Narrow" panose="020B0606020202030204" pitchFamily="34" charset="0"/>
                <a:sym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94094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E8D64C68-878C-4546-85B1-A38BB586E20C}"/>
              </a:ext>
            </a:extLst>
          </p:cNvPr>
          <p:cNvSpPr txBox="1"/>
          <p:nvPr/>
        </p:nvSpPr>
        <p:spPr>
          <a:xfrm>
            <a:off x="2000671" y="4337371"/>
            <a:ext cx="5760000" cy="20439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GB" sz="1000" b="1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Fig. S2: Separation and sugar residue composition of medium-sized oligosaccharides obtained by Driselase digestion of </a:t>
            </a:r>
            <a:r>
              <a:rPr lang="en-GB" sz="1000" b="1" i="1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Klebsormidium</a:t>
            </a:r>
            <a:r>
              <a:rPr lang="en-GB" sz="1000" b="1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 pectic fraction.</a:t>
            </a:r>
            <a:endParaRPr lang="en-GB" sz="100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GB" sz="100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(a) Ten oligosaccharides (D1–D10) were documented by analytical TLC of small portions of Bio-Gel P-2 fractions 14–20 (see Fig. 6). This image shows D1–D4 (from Bio-Gel fraction 17) and D5–D10 (from Bio-Gel fraction 20). TLC was in BAW with 3 ascents. On the basis of analytical TLCs such as these, D1–D10 were purified by preparative TLC (not shown). D1, D2 and D3 were obtained from Bio-Gel fractions 14–18; D4 was from 14–20; D5, D7, D8, D9 and D10 were from 19 + 20; and D6 was from 17–20. Note: two sections of the same plate were digitally attached together for clarity. </a:t>
            </a:r>
            <a:endParaRPr lang="en-GB" sz="100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GB" sz="1000">
                <a:effectLst/>
                <a:latin typeface="Century Schoolbook" panose="02040604050505020304" pitchFamily="18" charset="0"/>
                <a:ea typeface="Century Schoolbook" panose="02040604050505020304" pitchFamily="18" charset="0"/>
                <a:cs typeface="Century Schoolbook" panose="02040604050505020304" pitchFamily="18" charset="0"/>
              </a:rPr>
              <a:t>(b) Purified D1–D10 were analysed for monosaccharide composition: their acid hydrolysis products (2 M TFA, 120°C, 1 h) were resolved by TLC in EPAW with 2 ascents. </a:t>
            </a:r>
            <a:endParaRPr lang="en-GB" sz="1000">
              <a:effectLst/>
              <a:latin typeface="Century Schoolbook" panose="02040604050505020304" pitchFamily="18" charset="0"/>
              <a:ea typeface="Calibri" panose="020F0502020204030204" pitchFamily="34" charset="0"/>
            </a:endParaRPr>
          </a:p>
        </p:txBody>
      </p:sp>
      <p:pic>
        <p:nvPicPr>
          <p:cNvPr id="8" name="image10.png" descr="A close-up of a test&#10;&#10;Description automatically generated">
            <a:extLst>
              <a:ext uri="{FF2B5EF4-FFF2-40B4-BE49-F238E27FC236}">
                <a16:creationId xmlns:a16="http://schemas.microsoft.com/office/drawing/2014/main" xmlns="" id="{BACC3624-043A-4EDB-B4BD-0E2B5DAF51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00672" y="582903"/>
            <a:ext cx="5731510" cy="33756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2036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1</TotalTime>
  <Words>392</Words>
  <Application>Microsoft Office PowerPoint</Application>
  <PresentationFormat>A4 Paper (210x297 mm)</PresentationFormat>
  <Paragraphs>7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Fry</dc:creator>
  <cp:lastModifiedBy>Nandhakumar</cp:lastModifiedBy>
  <cp:revision>107</cp:revision>
  <cp:lastPrinted>2015-06-12T23:11:41Z</cp:lastPrinted>
  <dcterms:created xsi:type="dcterms:W3CDTF">2015-05-28T18:40:23Z</dcterms:created>
  <dcterms:modified xsi:type="dcterms:W3CDTF">2024-09-21T06:03:00Z</dcterms:modified>
</cp:coreProperties>
</file>